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80" d="100"/>
          <a:sy n="80" d="100"/>
        </p:scale>
        <p:origin x="1032" y="-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eiken.ycan.local\&#24494;&#29983;&#29289;&#26908;&#26619;&#30740;&#31350;&#35506;\&#20491;&#20154;\&#29066;&#23822;&#30495;&#29748;\Noro\Noro%20y17%202017.4-2018.3\&#37325;&#35079;data\&#37325;&#35079;&#22259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35287255759697"/>
          <c:y val="0.42435902055992292"/>
          <c:w val="0.74482589676290467"/>
          <c:h val="0.38709923225238696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'Fig1'!$E$2</c:f>
              <c:strCache>
                <c:ptCount val="1"/>
                <c:pt idx="0">
                  <c:v>K/Ns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2:$I$2</c:f>
              <c:numCache>
                <c:formatCode>General</c:formatCode>
                <c:ptCount val="4"/>
                <c:pt idx="1">
                  <c:v>14</c:v>
                </c:pt>
                <c:pt idx="2">
                  <c:v>42</c:v>
                </c:pt>
                <c:pt idx="3">
                  <c:v>4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71-4482-8F3D-6E208D259118}"/>
            </c:ext>
          </c:extLst>
        </c:ser>
        <c:ser>
          <c:idx val="1"/>
          <c:order val="1"/>
          <c:tx>
            <c:strRef>
              <c:f>'Fig1'!$E$3</c:f>
              <c:strCache>
                <c:ptCount val="1"/>
                <c:pt idx="0">
                  <c:v>PS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3:$I$3</c:f>
              <c:numCache>
                <c:formatCode>General</c:formatCode>
                <c:ptCount val="4"/>
                <c:pt idx="0">
                  <c:v>10</c:v>
                </c:pt>
                <c:pt idx="1">
                  <c:v>26</c:v>
                </c:pt>
                <c:pt idx="2">
                  <c:v>17</c:v>
                </c:pt>
                <c:pt idx="3">
                  <c:v>3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371-4482-8F3D-6E208D259118}"/>
            </c:ext>
          </c:extLst>
        </c:ser>
        <c:ser>
          <c:idx val="2"/>
          <c:order val="2"/>
          <c:tx>
            <c:strRef>
              <c:f>'Fig1'!$E$4</c:f>
              <c:strCache>
                <c:ptCount val="1"/>
                <c:pt idx="0">
                  <c:v>NHs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4:$I$4</c:f>
              <c:numCache>
                <c:formatCode>General</c:formatCode>
                <c:ptCount val="4"/>
                <c:pt idx="1">
                  <c:v>4</c:v>
                </c:pt>
                <c:pt idx="2">
                  <c:v>11</c:v>
                </c:pt>
                <c:pt idx="3">
                  <c:v>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371-4482-8F3D-6E208D259118}"/>
            </c:ext>
          </c:extLst>
        </c:ser>
        <c:ser>
          <c:idx val="3"/>
          <c:order val="3"/>
          <c:tx>
            <c:strRef>
              <c:f>'Fig1'!$E$5</c:f>
              <c:strCache>
                <c:ptCount val="1"/>
                <c:pt idx="0">
                  <c:v>Restaurant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5:$I$5</c:f>
              <c:numCache>
                <c:formatCode>General</c:formatCode>
                <c:ptCount val="4"/>
                <c:pt idx="1">
                  <c:v>2</c:v>
                </c:pt>
                <c:pt idx="2">
                  <c:v>2</c:v>
                </c:pt>
                <c:pt idx="3">
                  <c:v>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371-4482-8F3D-6E208D259118}"/>
            </c:ext>
          </c:extLst>
        </c:ser>
        <c:ser>
          <c:idx val="4"/>
          <c:order val="4"/>
          <c:tx>
            <c:strRef>
              <c:f>'Fig1'!$E$6</c:f>
              <c:strCache>
                <c:ptCount val="1"/>
                <c:pt idx="0">
                  <c:v>Welfare facilities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6:$I$6</c:f>
              <c:numCache>
                <c:formatCode>General</c:formatCode>
                <c:ptCount val="4"/>
                <c:pt idx="1">
                  <c:v>2</c:v>
                </c:pt>
                <c:pt idx="2">
                  <c:v>1</c:v>
                </c:pt>
                <c:pt idx="3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371-4482-8F3D-6E208D259118}"/>
            </c:ext>
          </c:extLst>
        </c:ser>
        <c:ser>
          <c:idx val="5"/>
          <c:order val="5"/>
          <c:tx>
            <c:strRef>
              <c:f>'Fig1'!$E$7</c:f>
              <c:strCache>
                <c:ptCount val="1"/>
                <c:pt idx="0">
                  <c:v>Hospitals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7:$I$7</c:f>
              <c:numCache>
                <c:formatCode>General</c:formatCode>
                <c:ptCount val="4"/>
                <c:pt idx="3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371-4482-8F3D-6E208D259118}"/>
            </c:ext>
          </c:extLst>
        </c:ser>
        <c:ser>
          <c:idx val="6"/>
          <c:order val="6"/>
          <c:tx>
            <c:strRef>
              <c:f>'Fig1'!$E$8</c:f>
              <c:strCache>
                <c:ptCount val="1"/>
                <c:pt idx="0">
                  <c:v>Junior and senior high schools, universities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8:$I$8</c:f>
              <c:numCache>
                <c:formatCode>General</c:formatCode>
                <c:ptCount val="4"/>
                <c:pt idx="3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371-4482-8F3D-6E208D259118}"/>
            </c:ext>
          </c:extLst>
        </c:ser>
        <c:ser>
          <c:idx val="9"/>
          <c:order val="7"/>
          <c:tx>
            <c:strRef>
              <c:f>'Fig1'!$E$9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Fig1'!$F$1:$I$1</c:f>
              <c:strCache>
                <c:ptCount val="4"/>
                <c:pt idx="0">
                  <c:v>RVC (N=10)</c:v>
                </c:pt>
                <c:pt idx="1">
                  <c:v>Sapovirus (N=49)</c:v>
                </c:pt>
                <c:pt idx="2">
                  <c:v>RVA (N=73)</c:v>
                </c:pt>
                <c:pt idx="3">
                  <c:v>Norovirus (N=1327)</c:v>
                </c:pt>
              </c:strCache>
            </c:strRef>
          </c:cat>
          <c:val>
            <c:numRef>
              <c:f>'Fig1'!$F$9:$I$9</c:f>
              <c:numCache>
                <c:formatCode>General</c:formatCode>
                <c:ptCount val="4"/>
                <c:pt idx="1">
                  <c:v>1</c:v>
                </c:pt>
                <c:pt idx="3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371-4482-8F3D-6E208D25911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50"/>
        <c:overlap val="100"/>
        <c:axId val="374096696"/>
        <c:axId val="370827656"/>
      </c:barChart>
      <c:catAx>
        <c:axId val="3740966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0827656"/>
        <c:crosses val="autoZero"/>
        <c:auto val="1"/>
        <c:lblAlgn val="ctr"/>
        <c:lblOffset val="100"/>
        <c:noMultiLvlLbl val="0"/>
      </c:catAx>
      <c:valAx>
        <c:axId val="370827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4096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3984018664333625"/>
          <c:y val="1.0480914419895142E-2"/>
          <c:w val="0.49809740449110529"/>
          <c:h val="0.361641063617499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+mn-lt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1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0085F5-FB85-4F53-9B4E-B343D6086034}" type="datetimeFigureOut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9371014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1014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BFF1CC-39F2-4452-BFF0-DFD98FCEB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8432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EAA18D-A955-4B17-BFE2-25C058089AAE}" type="datetimeFigureOut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1900"/>
            <a:ext cx="2303463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4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371287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1287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D2DFD3-5443-41F8-9417-2294FD841E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818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E1ABE-EF1C-47F0-A0FF-C7F5FCDAC8EE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312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90A6EA-CB17-4E6E-8B83-44FDE1C23D26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690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73BF6-B28C-473D-A1DA-761B13B3DD3F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502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6FA2F-2670-4201-B33E-3A5491F1DF1A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7549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19876-224F-498F-A1A6-BB681110E50D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989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3DB52-3281-42AF-8E20-D907A4AFC259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199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96C61-8903-4C61-884A-3672FA9CDD0F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130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1CA5D-5790-4BDC-A654-E9726D05A15C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16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0B4DB-0828-4D56-B8C6-E2133C0D4B29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224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DB52F-9264-4DF7-976D-1DB32B96A9BE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935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92A8D-05D2-4CA1-95B1-8A442D0A1229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013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2F567-CCC9-458C-BF67-A87699BC5255}" type="datetime1">
              <a:rPr kumimoji="1" lang="ja-JP" altLang="en-US" smtClean="0"/>
              <a:t>2022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 smtClean="0"/>
              <a:t>Fig.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83B92-B1D4-4D6E-AB17-74C41D1F3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362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14393" y="535577"/>
            <a:ext cx="6409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Additional file 2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Distribution of settings where AG viruses were detected in Yokohama, Japan, 2007–2017</a:t>
            </a:r>
            <a:endParaRPr kumimoji="1" lang="ja-JP" altLang="en-US" sz="1200" dirty="0"/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7970622"/>
              </p:ext>
            </p:extLst>
          </p:nvPr>
        </p:nvGraphicFramePr>
        <p:xfrm>
          <a:off x="0" y="1291663"/>
          <a:ext cx="6858000" cy="3635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73180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17</Words>
  <Application>Microsoft Office PowerPoint</Application>
  <PresentationFormat>A4 210 x 297 mm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熊崎 真琴</dc:creator>
  <cp:lastModifiedBy>熊崎 真琴</cp:lastModifiedBy>
  <cp:revision>27</cp:revision>
  <cp:lastPrinted>2017-12-07T07:52:47Z</cp:lastPrinted>
  <dcterms:created xsi:type="dcterms:W3CDTF">2017-12-05T02:12:26Z</dcterms:created>
  <dcterms:modified xsi:type="dcterms:W3CDTF">2022-12-27T05:35:26Z</dcterms:modified>
</cp:coreProperties>
</file>